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464" y="-91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3FBD22-D475-4766-961C-67A9D5AAC197}" type="datetimeFigureOut">
              <a:rPr lang="zh-CN" altLang="en-US" smtClean="0"/>
              <a:t>2016/12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1B5D9C-CE14-4D4C-AFF9-1CCDCE6230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19145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58-63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CFC5BD-1DC6-4ABC-AB5F-B2347C6E930A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60755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2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2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2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6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组合 67"/>
          <p:cNvGrpSpPr/>
          <p:nvPr/>
        </p:nvGrpSpPr>
        <p:grpSpPr>
          <a:xfrm>
            <a:off x="811057" y="332656"/>
            <a:ext cx="5529652" cy="6120680"/>
            <a:chOff x="811057" y="332656"/>
            <a:chExt cx="5529652" cy="612068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36" t="8010" r="84829" b="72935"/>
            <a:stretch/>
          </p:blipFill>
          <p:spPr>
            <a:xfrm>
              <a:off x="1962150" y="822481"/>
              <a:ext cx="900998" cy="1321600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97" t="61050" r="84210" b="18262"/>
            <a:stretch/>
          </p:blipFill>
          <p:spPr>
            <a:xfrm>
              <a:off x="1962149" y="2180757"/>
              <a:ext cx="910225" cy="1475492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61" r="83381" b="77834"/>
            <a:stretch/>
          </p:blipFill>
          <p:spPr>
            <a:xfrm>
              <a:off x="1962150" y="3717032"/>
              <a:ext cx="900998" cy="1353949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58" t="54307" r="83762" b="23527"/>
            <a:stretch/>
          </p:blipFill>
          <p:spPr>
            <a:xfrm>
              <a:off x="1962149" y="5096409"/>
              <a:ext cx="900999" cy="1356927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899592" y="332656"/>
              <a:ext cx="6671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A: 58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811057" y="1207977"/>
              <a:ext cx="10246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Genomic</a:t>
              </a:r>
              <a:endParaRPr lang="zh-CN" alt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11057" y="2733837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0 DAH</a:t>
              </a:r>
              <a:endParaRPr lang="zh-CN" altLang="en-US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811057" y="4148557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1 DAH</a:t>
              </a:r>
              <a:endParaRPr lang="zh-CN" altLang="en-US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811057" y="5600465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3 DAH</a:t>
              </a:r>
              <a:endParaRPr lang="zh-CN" altLang="en-US" dirty="0"/>
            </a:p>
          </p:txBody>
        </p:sp>
        <p:pic>
          <p:nvPicPr>
            <p:cNvPr id="45" name="图片 4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10" t="8010" r="70348" b="72935"/>
            <a:stretch/>
          </p:blipFill>
          <p:spPr>
            <a:xfrm>
              <a:off x="2910085" y="822481"/>
              <a:ext cx="1186735" cy="1321600"/>
            </a:xfrm>
            <a:prstGeom prst="rect">
              <a:avLst/>
            </a:prstGeom>
          </p:spPr>
        </p:pic>
        <p:pic>
          <p:nvPicPr>
            <p:cNvPr id="46" name="图片 4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005" t="8010" r="56017" b="72935"/>
            <a:stretch/>
          </p:blipFill>
          <p:spPr>
            <a:xfrm>
              <a:off x="4163937" y="785678"/>
              <a:ext cx="1200151" cy="1321600"/>
            </a:xfrm>
            <a:prstGeom prst="rect">
              <a:avLst/>
            </a:prstGeom>
          </p:spPr>
        </p:pic>
        <p:pic>
          <p:nvPicPr>
            <p:cNvPr id="47" name="图片 4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475" t="8010" r="37013" b="72935"/>
            <a:stretch/>
          </p:blipFill>
          <p:spPr>
            <a:xfrm>
              <a:off x="5391124" y="810394"/>
              <a:ext cx="837060" cy="1321600"/>
            </a:xfrm>
            <a:prstGeom prst="rect">
              <a:avLst/>
            </a:prstGeom>
          </p:spPr>
        </p:pic>
        <p:pic>
          <p:nvPicPr>
            <p:cNvPr id="49" name="图片 48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12" t="61050" r="69274" b="18262"/>
            <a:stretch/>
          </p:blipFill>
          <p:spPr>
            <a:xfrm>
              <a:off x="2920751" y="2180757"/>
              <a:ext cx="1219201" cy="1475492"/>
            </a:xfrm>
            <a:prstGeom prst="rect">
              <a:avLst/>
            </a:prstGeom>
          </p:spPr>
        </p:pic>
        <p:pic>
          <p:nvPicPr>
            <p:cNvPr id="50" name="图片 49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418" t="61050" r="54460" b="18262"/>
            <a:stretch/>
          </p:blipFill>
          <p:spPr>
            <a:xfrm>
              <a:off x="4163937" y="2173425"/>
              <a:ext cx="1200151" cy="1475492"/>
            </a:xfrm>
            <a:prstGeom prst="rect">
              <a:avLst/>
            </a:prstGeom>
          </p:spPr>
        </p:pic>
        <p:pic>
          <p:nvPicPr>
            <p:cNvPr id="51" name="图片 50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480" t="61050" r="36541" b="18262"/>
            <a:stretch/>
          </p:blipFill>
          <p:spPr>
            <a:xfrm>
              <a:off x="5391124" y="2169532"/>
              <a:ext cx="789954" cy="1475492"/>
            </a:xfrm>
            <a:prstGeom prst="rect">
              <a:avLst/>
            </a:prstGeom>
          </p:spPr>
        </p:pic>
        <p:pic>
          <p:nvPicPr>
            <p:cNvPr id="52" name="图片 5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536" r="19475" b="77834"/>
            <a:stretch/>
          </p:blipFill>
          <p:spPr>
            <a:xfrm>
              <a:off x="5390391" y="3704412"/>
              <a:ext cx="837793" cy="1353949"/>
            </a:xfrm>
            <a:prstGeom prst="rect">
              <a:avLst/>
            </a:prstGeom>
          </p:spPr>
        </p:pic>
        <p:pic>
          <p:nvPicPr>
            <p:cNvPr id="54" name="图片 53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853" r="47878" b="77834"/>
            <a:stretch/>
          </p:blipFill>
          <p:spPr>
            <a:xfrm>
              <a:off x="4142646" y="3710209"/>
              <a:ext cx="1221442" cy="1353949"/>
            </a:xfrm>
            <a:prstGeom prst="rect">
              <a:avLst/>
            </a:prstGeom>
          </p:spPr>
        </p:pic>
        <p:pic>
          <p:nvPicPr>
            <p:cNvPr id="55" name="图片 54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45" r="65682" b="77834"/>
            <a:stretch/>
          </p:blipFill>
          <p:spPr>
            <a:xfrm>
              <a:off x="2925783" y="3717031"/>
              <a:ext cx="1171037" cy="1353949"/>
            </a:xfrm>
            <a:prstGeom prst="rect">
              <a:avLst/>
            </a:prstGeom>
          </p:spPr>
        </p:pic>
        <p:pic>
          <p:nvPicPr>
            <p:cNvPr id="56" name="图片 55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429" t="54307" r="18839" b="23527"/>
            <a:stretch/>
          </p:blipFill>
          <p:spPr>
            <a:xfrm>
              <a:off x="5423892" y="5096408"/>
              <a:ext cx="876300" cy="1356927"/>
            </a:xfrm>
            <a:prstGeom prst="rect">
              <a:avLst/>
            </a:prstGeom>
          </p:spPr>
        </p:pic>
        <p:pic>
          <p:nvPicPr>
            <p:cNvPr id="57" name="图片 56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871" t="54307" r="65823" b="23527"/>
            <a:stretch/>
          </p:blipFill>
          <p:spPr>
            <a:xfrm>
              <a:off x="2899787" y="5096409"/>
              <a:ext cx="1168157" cy="1356927"/>
            </a:xfrm>
            <a:prstGeom prst="rect">
              <a:avLst/>
            </a:prstGeom>
          </p:spPr>
        </p:pic>
        <p:pic>
          <p:nvPicPr>
            <p:cNvPr id="58" name="图片 57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793" t="54307" r="47209" b="23527"/>
            <a:stretch/>
          </p:blipFill>
          <p:spPr>
            <a:xfrm>
              <a:off x="4139952" y="5096409"/>
              <a:ext cx="1224136" cy="1356927"/>
            </a:xfrm>
            <a:prstGeom prst="rect">
              <a:avLst/>
            </a:prstGeom>
          </p:spPr>
        </p:pic>
        <p:sp>
          <p:nvSpPr>
            <p:cNvPr id="59" name="TextBox 58"/>
            <p:cNvSpPr txBox="1"/>
            <p:nvPr/>
          </p:nvSpPr>
          <p:spPr>
            <a:xfrm>
              <a:off x="2412648" y="332656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7</a:t>
              </a:r>
              <a:endParaRPr lang="zh-CN" altLang="en-US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861928" y="332656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4</a:t>
              </a:r>
              <a:endParaRPr lang="zh-CN" altLang="en-US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261948" y="332656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6</a:t>
              </a:r>
              <a:endParaRPr lang="zh-CN" altLang="en-US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621988" y="353647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3</a:t>
              </a:r>
              <a:endParaRPr lang="zh-CN" altLang="en-US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4142646" y="352724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2</a:t>
              </a:r>
              <a:endParaRPr lang="zh-CN" altLang="en-US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558092" y="353647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1</a:t>
              </a:r>
              <a:endParaRPr lang="zh-CN" altLang="en-US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990140" y="353647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5</a:t>
              </a:r>
              <a:endParaRPr lang="zh-CN" altLang="en-US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5398318" y="332656"/>
              <a:ext cx="5174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+</a:t>
              </a:r>
              <a:r>
                <a:rPr lang="en-US" altLang="zh-CN" dirty="0" err="1" smtClean="0"/>
                <a:t>ve</a:t>
              </a:r>
              <a:endParaRPr lang="zh-CN" altLang="en-US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5868144" y="332656"/>
              <a:ext cx="47256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-</a:t>
              </a:r>
              <a:r>
                <a:rPr lang="en-US" altLang="zh-CN" dirty="0" err="1" smtClean="0"/>
                <a:t>ve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125629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组合 58"/>
          <p:cNvGrpSpPr/>
          <p:nvPr/>
        </p:nvGrpSpPr>
        <p:grpSpPr>
          <a:xfrm>
            <a:off x="667041" y="371764"/>
            <a:ext cx="5121609" cy="5997763"/>
            <a:chOff x="667041" y="371764"/>
            <a:chExt cx="5121609" cy="5997763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84" t="10597" r="87637" b="68987"/>
            <a:stretch/>
          </p:blipFill>
          <p:spPr>
            <a:xfrm>
              <a:off x="1876424" y="836712"/>
              <a:ext cx="766201" cy="1399593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82" t="67270" r="87148" b="13266"/>
            <a:stretch/>
          </p:blipFill>
          <p:spPr>
            <a:xfrm>
              <a:off x="1876424" y="2267745"/>
              <a:ext cx="766201" cy="1334277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69" t="5016" r="83939" b="75656"/>
            <a:stretch/>
          </p:blipFill>
          <p:spPr>
            <a:xfrm>
              <a:off x="1876424" y="3645026"/>
              <a:ext cx="766201" cy="1324947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76" t="61845" r="84407" b="19236"/>
            <a:stretch/>
          </p:blipFill>
          <p:spPr>
            <a:xfrm>
              <a:off x="1876425" y="5063686"/>
              <a:ext cx="766200" cy="129695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744493" y="467380"/>
              <a:ext cx="6591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B: 59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67041" y="1124744"/>
              <a:ext cx="10246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Genomic</a:t>
              </a:r>
              <a:endParaRPr lang="zh-CN" alt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65296" y="2650604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0 DAH</a:t>
              </a:r>
              <a:endParaRPr lang="zh-CN" alt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93773" y="4030617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1 DAH</a:t>
              </a:r>
              <a:endParaRPr lang="zh-CN" altLang="en-US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93773" y="5527496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3 DAH</a:t>
              </a:r>
              <a:endParaRPr lang="zh-CN" altLang="en-US" dirty="0"/>
            </a:p>
          </p:txBody>
        </p:sp>
        <p:pic>
          <p:nvPicPr>
            <p:cNvPr id="38" name="图片 3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034" t="10597" r="39799" b="68987"/>
            <a:stretch/>
          </p:blipFill>
          <p:spPr>
            <a:xfrm>
              <a:off x="4852247" y="820173"/>
              <a:ext cx="746762" cy="1399593"/>
            </a:xfrm>
            <a:prstGeom prst="rect">
              <a:avLst/>
            </a:prstGeom>
          </p:spPr>
        </p:pic>
        <p:pic>
          <p:nvPicPr>
            <p:cNvPr id="39" name="图片 38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126" t="10597" r="58624" b="68987"/>
            <a:stretch/>
          </p:blipFill>
          <p:spPr>
            <a:xfrm>
              <a:off x="3776974" y="820174"/>
              <a:ext cx="1028701" cy="1399593"/>
            </a:xfrm>
            <a:prstGeom prst="rect">
              <a:avLst/>
            </a:prstGeom>
          </p:spPr>
        </p:pic>
        <p:pic>
          <p:nvPicPr>
            <p:cNvPr id="40" name="图片 39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33" t="10597" r="73209" b="68987"/>
            <a:stretch/>
          </p:blipFill>
          <p:spPr>
            <a:xfrm>
              <a:off x="2687497" y="823976"/>
              <a:ext cx="1047750" cy="1399593"/>
            </a:xfrm>
            <a:prstGeom prst="rect">
              <a:avLst/>
            </a:prstGeom>
          </p:spPr>
        </p:pic>
        <p:pic>
          <p:nvPicPr>
            <p:cNvPr id="41" name="图片 40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535" t="67270" r="38986" b="13266"/>
            <a:stretch/>
          </p:blipFill>
          <p:spPr>
            <a:xfrm>
              <a:off x="4860032" y="2267744"/>
              <a:ext cx="866775" cy="1334277"/>
            </a:xfrm>
            <a:prstGeom prst="rect">
              <a:avLst/>
            </a:prstGeom>
          </p:spPr>
        </p:pic>
        <p:pic>
          <p:nvPicPr>
            <p:cNvPr id="42" name="图片 4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631" t="67270" r="58074" b="13266"/>
            <a:stretch/>
          </p:blipFill>
          <p:spPr>
            <a:xfrm>
              <a:off x="3765006" y="2278080"/>
              <a:ext cx="1040669" cy="1334277"/>
            </a:xfrm>
            <a:prstGeom prst="rect">
              <a:avLst/>
            </a:prstGeom>
          </p:spPr>
        </p:pic>
        <p:pic>
          <p:nvPicPr>
            <p:cNvPr id="43" name="图片 4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68" t="67270" r="72928" b="13266"/>
            <a:stretch/>
          </p:blipFill>
          <p:spPr>
            <a:xfrm>
              <a:off x="2691544" y="2267745"/>
              <a:ext cx="1043704" cy="1334277"/>
            </a:xfrm>
            <a:prstGeom prst="rect">
              <a:avLst/>
            </a:prstGeom>
          </p:spPr>
        </p:pic>
        <p:pic>
          <p:nvPicPr>
            <p:cNvPr id="44" name="图片 4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858" t="5016" r="25351" b="75656"/>
            <a:stretch/>
          </p:blipFill>
          <p:spPr>
            <a:xfrm>
              <a:off x="4893300" y="3645024"/>
              <a:ext cx="895350" cy="1324947"/>
            </a:xfrm>
            <a:prstGeom prst="rect">
              <a:avLst/>
            </a:prstGeom>
          </p:spPr>
        </p:pic>
        <p:pic>
          <p:nvPicPr>
            <p:cNvPr id="45" name="图片 4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376" t="5016" r="48457" b="75656"/>
            <a:stretch/>
          </p:blipFill>
          <p:spPr>
            <a:xfrm>
              <a:off x="3793908" y="3645025"/>
              <a:ext cx="994831" cy="1324947"/>
            </a:xfrm>
            <a:prstGeom prst="rect">
              <a:avLst/>
            </a:prstGeom>
          </p:spPr>
        </p:pic>
        <p:pic>
          <p:nvPicPr>
            <p:cNvPr id="46" name="图片 4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570" t="5016" r="66680" b="75656"/>
            <a:stretch/>
          </p:blipFill>
          <p:spPr>
            <a:xfrm>
              <a:off x="2714745" y="3645026"/>
              <a:ext cx="1020502" cy="1324947"/>
            </a:xfrm>
            <a:prstGeom prst="rect">
              <a:avLst/>
            </a:prstGeom>
          </p:spPr>
        </p:pic>
        <p:pic>
          <p:nvPicPr>
            <p:cNvPr id="47" name="图片 4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80" t="61845" r="66066" b="19236"/>
            <a:stretch/>
          </p:blipFill>
          <p:spPr>
            <a:xfrm>
              <a:off x="2714746" y="5063685"/>
              <a:ext cx="1020502" cy="1296955"/>
            </a:xfrm>
            <a:prstGeom prst="rect">
              <a:avLst/>
            </a:prstGeom>
          </p:spPr>
        </p:pic>
        <p:pic>
          <p:nvPicPr>
            <p:cNvPr id="48" name="图片 47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77" t="61845" r="47648" b="19236"/>
            <a:stretch/>
          </p:blipFill>
          <p:spPr>
            <a:xfrm>
              <a:off x="3793908" y="5072572"/>
              <a:ext cx="994831" cy="1296955"/>
            </a:xfrm>
            <a:prstGeom prst="rect">
              <a:avLst/>
            </a:prstGeom>
          </p:spPr>
        </p:pic>
        <p:pic>
          <p:nvPicPr>
            <p:cNvPr id="49" name="图片 48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850" t="61845" r="24463" b="19236"/>
            <a:stretch/>
          </p:blipFill>
          <p:spPr>
            <a:xfrm>
              <a:off x="4893300" y="5072572"/>
              <a:ext cx="885825" cy="1296955"/>
            </a:xfrm>
            <a:prstGeom prst="rect">
              <a:avLst/>
            </a:prstGeom>
          </p:spPr>
        </p:pic>
        <p:sp>
          <p:nvSpPr>
            <p:cNvPr id="50" name="TextBox 49"/>
            <p:cNvSpPr txBox="1"/>
            <p:nvPr/>
          </p:nvSpPr>
          <p:spPr>
            <a:xfrm>
              <a:off x="2196669" y="391565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7</a:t>
              </a:r>
              <a:endParaRPr lang="zh-CN" altLang="en-US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613876" y="391565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4</a:t>
              </a:r>
              <a:endParaRPr lang="zh-CN" altLang="en-US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973916" y="391565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6</a:t>
              </a:r>
              <a:endParaRPr lang="zh-CN" altLang="en-US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308977" y="391565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3</a:t>
              </a:r>
              <a:endParaRPr lang="zh-CN" altLang="en-US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3707904" y="395372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2</a:t>
              </a:r>
              <a:endParaRPr lang="zh-CN" altLang="en-US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067944" y="395372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1</a:t>
              </a:r>
              <a:endParaRPr lang="zh-CN" altLang="en-US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414076" y="395372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5</a:t>
              </a:r>
              <a:endParaRPr lang="zh-CN" altLang="en-US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805675" y="371764"/>
              <a:ext cx="5174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+</a:t>
              </a:r>
              <a:r>
                <a:rPr lang="en-US" altLang="zh-CN" dirty="0" err="1" smtClean="0"/>
                <a:t>ve</a:t>
              </a:r>
              <a:endParaRPr lang="zh-CN" altLang="en-US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5293976" y="383287"/>
              <a:ext cx="47256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-</a:t>
              </a:r>
              <a:r>
                <a:rPr lang="en-US" altLang="zh-CN" dirty="0" err="1" smtClean="0"/>
                <a:t>ve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7702954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组合 57"/>
          <p:cNvGrpSpPr/>
          <p:nvPr/>
        </p:nvGrpSpPr>
        <p:grpSpPr>
          <a:xfrm>
            <a:off x="107504" y="1175950"/>
            <a:ext cx="5536978" cy="5061095"/>
            <a:chOff x="107504" y="1175950"/>
            <a:chExt cx="5536978" cy="5061095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23" t="9508" r="84305" b="74703"/>
            <a:stretch/>
          </p:blipFill>
          <p:spPr>
            <a:xfrm>
              <a:off x="1167604" y="1623543"/>
              <a:ext cx="885046" cy="1082351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23" t="66102" r="83223" b="17430"/>
            <a:stretch/>
          </p:blipFill>
          <p:spPr>
            <a:xfrm>
              <a:off x="1167604" y="2849894"/>
              <a:ext cx="885046" cy="1129004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03" t="11005" r="85559" b="72662"/>
            <a:stretch/>
          </p:blipFill>
          <p:spPr>
            <a:xfrm>
              <a:off x="1167604" y="4042605"/>
              <a:ext cx="872125" cy="1119674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13" t="67194" r="85308" b="18107"/>
            <a:stretch/>
          </p:blipFill>
          <p:spPr>
            <a:xfrm>
              <a:off x="1167604" y="5221712"/>
              <a:ext cx="885046" cy="1007707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205759" y="1196752"/>
              <a:ext cx="6575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C: 60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07504" y="1907540"/>
              <a:ext cx="10246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Genomic</a:t>
              </a:r>
              <a:endParaRPr lang="zh-CN" alt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05759" y="3203684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0 DAH</a:t>
              </a:r>
              <a:endParaRPr lang="zh-CN" alt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05758" y="4437112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1 DAH</a:t>
              </a:r>
              <a:endParaRPr lang="zh-CN" altLang="en-US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05757" y="5576297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3 DAH</a:t>
              </a:r>
              <a:endParaRPr lang="zh-CN" altLang="en-US" dirty="0"/>
            </a:p>
          </p:txBody>
        </p:sp>
        <p:pic>
          <p:nvPicPr>
            <p:cNvPr id="37" name="图片 3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801" t="9508" r="36699" b="74703"/>
            <a:stretch/>
          </p:blipFill>
          <p:spPr>
            <a:xfrm>
              <a:off x="4672390" y="1623540"/>
              <a:ext cx="837610" cy="1082351"/>
            </a:xfrm>
            <a:prstGeom prst="rect">
              <a:avLst/>
            </a:prstGeom>
          </p:spPr>
        </p:pic>
        <p:pic>
          <p:nvPicPr>
            <p:cNvPr id="38" name="图片 3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63" t="9508" r="54787" b="74703"/>
            <a:stretch/>
          </p:blipFill>
          <p:spPr>
            <a:xfrm>
              <a:off x="3362026" y="1623543"/>
              <a:ext cx="1266825" cy="1082351"/>
            </a:xfrm>
            <a:prstGeom prst="rect">
              <a:avLst/>
            </a:prstGeom>
          </p:spPr>
        </p:pic>
        <p:pic>
          <p:nvPicPr>
            <p:cNvPr id="39" name="图片 38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75" t="9508" r="69062" b="74703"/>
            <a:stretch/>
          </p:blipFill>
          <p:spPr>
            <a:xfrm>
              <a:off x="2092585" y="1623542"/>
              <a:ext cx="1216392" cy="1082351"/>
            </a:xfrm>
            <a:prstGeom prst="rect">
              <a:avLst/>
            </a:prstGeom>
          </p:spPr>
        </p:pic>
        <p:pic>
          <p:nvPicPr>
            <p:cNvPr id="40" name="图片 39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105" t="66102" r="34833" b="17430"/>
            <a:stretch/>
          </p:blipFill>
          <p:spPr>
            <a:xfrm>
              <a:off x="4681493" y="2849894"/>
              <a:ext cx="828675" cy="1129004"/>
            </a:xfrm>
            <a:prstGeom prst="rect">
              <a:avLst/>
            </a:prstGeom>
          </p:spPr>
        </p:pic>
        <p:pic>
          <p:nvPicPr>
            <p:cNvPr id="41" name="图片 40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044" t="66102" r="53664" b="17430"/>
            <a:stretch/>
          </p:blipFill>
          <p:spPr>
            <a:xfrm>
              <a:off x="3343395" y="2849894"/>
              <a:ext cx="1285456" cy="1129004"/>
            </a:xfrm>
            <a:prstGeom prst="rect">
              <a:avLst/>
            </a:prstGeom>
          </p:spPr>
        </p:pic>
        <p:pic>
          <p:nvPicPr>
            <p:cNvPr id="42" name="图片 4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52" t="66102" r="69665" b="17430"/>
            <a:stretch/>
          </p:blipFill>
          <p:spPr>
            <a:xfrm>
              <a:off x="2092012" y="2849894"/>
              <a:ext cx="1216965" cy="1129004"/>
            </a:xfrm>
            <a:prstGeom prst="rect">
              <a:avLst/>
            </a:prstGeom>
          </p:spPr>
        </p:pic>
        <p:pic>
          <p:nvPicPr>
            <p:cNvPr id="43" name="图片 4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10" t="11005" r="67040" b="72662"/>
            <a:stretch/>
          </p:blipFill>
          <p:spPr>
            <a:xfrm>
              <a:off x="2092584" y="4047051"/>
              <a:ext cx="1217365" cy="1119674"/>
            </a:xfrm>
            <a:prstGeom prst="rect">
              <a:avLst/>
            </a:prstGeom>
          </p:spPr>
        </p:pic>
        <p:pic>
          <p:nvPicPr>
            <p:cNvPr id="44" name="图片 4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211" t="11005" r="48935" b="72662"/>
            <a:stretch/>
          </p:blipFill>
          <p:spPr>
            <a:xfrm>
              <a:off x="3362027" y="4024741"/>
              <a:ext cx="1266825" cy="1119674"/>
            </a:xfrm>
            <a:prstGeom prst="rect">
              <a:avLst/>
            </a:prstGeom>
          </p:spPr>
        </p:pic>
        <p:pic>
          <p:nvPicPr>
            <p:cNvPr id="45" name="图片 4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512" t="11005" r="26113" b="72662"/>
            <a:stretch/>
          </p:blipFill>
          <p:spPr>
            <a:xfrm>
              <a:off x="4672390" y="4024741"/>
              <a:ext cx="857250" cy="1119674"/>
            </a:xfrm>
            <a:prstGeom prst="rect">
              <a:avLst/>
            </a:prstGeom>
          </p:spPr>
        </p:pic>
        <p:pic>
          <p:nvPicPr>
            <p:cNvPr id="46" name="图片 4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538" t="67194" r="66775" b="18107"/>
            <a:stretch/>
          </p:blipFill>
          <p:spPr>
            <a:xfrm>
              <a:off x="2092586" y="5220638"/>
              <a:ext cx="1216392" cy="1007707"/>
            </a:xfrm>
            <a:prstGeom prst="rect">
              <a:avLst/>
            </a:prstGeom>
          </p:spPr>
        </p:pic>
        <p:pic>
          <p:nvPicPr>
            <p:cNvPr id="47" name="图片 4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719" t="67194" r="48010" b="18107"/>
            <a:stretch/>
          </p:blipFill>
          <p:spPr>
            <a:xfrm>
              <a:off x="3362027" y="5229338"/>
              <a:ext cx="1271094" cy="1007707"/>
            </a:xfrm>
            <a:prstGeom prst="rect">
              <a:avLst/>
            </a:prstGeom>
          </p:spPr>
        </p:pic>
        <p:pic>
          <p:nvPicPr>
            <p:cNvPr id="48" name="图片 47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456" t="67194" r="25481" b="18107"/>
            <a:stretch/>
          </p:blipFill>
          <p:spPr>
            <a:xfrm>
              <a:off x="4676857" y="5220636"/>
              <a:ext cx="828675" cy="1007707"/>
            </a:xfrm>
            <a:prstGeom prst="rect">
              <a:avLst/>
            </a:prstGeom>
          </p:spPr>
        </p:pic>
        <p:sp>
          <p:nvSpPr>
            <p:cNvPr id="49" name="TextBox 48"/>
            <p:cNvSpPr txBox="1"/>
            <p:nvPr/>
          </p:nvSpPr>
          <p:spPr>
            <a:xfrm>
              <a:off x="1636699" y="1196752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7</a:t>
              </a:r>
              <a:endParaRPr lang="zh-CN" altLang="en-US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080809" y="1195829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4</a:t>
              </a:r>
              <a:endParaRPr lang="zh-CN" altLang="en-US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429331" y="1195829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6</a:t>
              </a:r>
              <a:endParaRPr lang="zh-CN" altLang="en-US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840869" y="1190861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3</a:t>
              </a:r>
              <a:endParaRPr lang="zh-CN" altLang="en-US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384697" y="1195829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2</a:t>
              </a:r>
              <a:endParaRPr lang="zh-CN" altLang="en-US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3768143" y="1195829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1</a:t>
              </a:r>
              <a:endParaRPr lang="zh-CN" altLang="en-US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203579" y="1195829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5</a:t>
              </a:r>
              <a:endParaRPr lang="zh-CN" altLang="en-US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665965" y="1180608"/>
              <a:ext cx="5174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+</a:t>
              </a:r>
              <a:r>
                <a:rPr lang="en-US" altLang="zh-CN" dirty="0" err="1" smtClean="0"/>
                <a:t>ve</a:t>
              </a:r>
              <a:endParaRPr lang="zh-CN" altLang="en-US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171917" y="1175950"/>
              <a:ext cx="47256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-</a:t>
              </a:r>
              <a:r>
                <a:rPr lang="en-US" altLang="zh-CN" dirty="0" err="1" smtClean="0"/>
                <a:t>ve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5843368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组合 57"/>
          <p:cNvGrpSpPr/>
          <p:nvPr/>
        </p:nvGrpSpPr>
        <p:grpSpPr>
          <a:xfrm>
            <a:off x="415988" y="462412"/>
            <a:ext cx="5876887" cy="5817833"/>
            <a:chOff x="415988" y="462412"/>
            <a:chExt cx="5876887" cy="5817833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82" r="87187" b="79604"/>
            <a:stretch/>
          </p:blipFill>
          <p:spPr>
            <a:xfrm>
              <a:off x="1609725" y="876398"/>
              <a:ext cx="969072" cy="1398239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5" t="57920" r="86913" b="22889"/>
            <a:stretch/>
          </p:blipFill>
          <p:spPr>
            <a:xfrm>
              <a:off x="1609725" y="2392151"/>
              <a:ext cx="969072" cy="1315617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48" t="8147" r="81054" b="73887"/>
            <a:stretch/>
          </p:blipFill>
          <p:spPr>
            <a:xfrm>
              <a:off x="1609725" y="3726429"/>
              <a:ext cx="969072" cy="1231641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61" t="64609" r="79722" b="17560"/>
            <a:stretch/>
          </p:blipFill>
          <p:spPr>
            <a:xfrm>
              <a:off x="1626185" y="5056446"/>
              <a:ext cx="952612" cy="1222311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510373" y="538840"/>
              <a:ext cx="6767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D: 61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15988" y="1179370"/>
              <a:ext cx="10246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Genomic</a:t>
              </a:r>
              <a:endParaRPr lang="zh-CN" alt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15988" y="2637356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0 DAH</a:t>
              </a:r>
              <a:endParaRPr lang="zh-CN" alt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15988" y="4058609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1 DAH</a:t>
              </a:r>
              <a:endParaRPr lang="zh-CN" altLang="en-US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15988" y="5482934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3 DAH</a:t>
              </a:r>
              <a:endParaRPr lang="zh-CN" altLang="en-US" dirty="0"/>
            </a:p>
          </p:txBody>
        </p:sp>
        <p:pic>
          <p:nvPicPr>
            <p:cNvPr id="37" name="图片 3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576" r="39674" b="79604"/>
            <a:stretch/>
          </p:blipFill>
          <p:spPr>
            <a:xfrm>
              <a:off x="5370963" y="908171"/>
              <a:ext cx="883086" cy="1398239"/>
            </a:xfrm>
            <a:prstGeom prst="rect">
              <a:avLst/>
            </a:prstGeom>
          </p:spPr>
        </p:pic>
        <p:pic>
          <p:nvPicPr>
            <p:cNvPr id="38" name="图片 3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119" r="58714" b="79604"/>
            <a:stretch/>
          </p:blipFill>
          <p:spPr>
            <a:xfrm>
              <a:off x="4026738" y="908172"/>
              <a:ext cx="1287076" cy="1398239"/>
            </a:xfrm>
            <a:prstGeom prst="rect">
              <a:avLst/>
            </a:prstGeom>
          </p:spPr>
        </p:pic>
        <p:pic>
          <p:nvPicPr>
            <p:cNvPr id="39" name="图片 38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266" r="73692" b="79604"/>
            <a:stretch/>
          </p:blipFill>
          <p:spPr>
            <a:xfrm>
              <a:off x="2637431" y="876397"/>
              <a:ext cx="1293451" cy="1398239"/>
            </a:xfrm>
            <a:prstGeom prst="rect">
              <a:avLst/>
            </a:prstGeom>
          </p:spPr>
        </p:pic>
        <p:pic>
          <p:nvPicPr>
            <p:cNvPr id="40" name="图片 39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872" t="57920" r="39591" b="22889"/>
            <a:stretch/>
          </p:blipFill>
          <p:spPr>
            <a:xfrm>
              <a:off x="5341711" y="2362127"/>
              <a:ext cx="912338" cy="1315617"/>
            </a:xfrm>
            <a:prstGeom prst="rect">
              <a:avLst/>
            </a:prstGeom>
          </p:spPr>
        </p:pic>
        <p:pic>
          <p:nvPicPr>
            <p:cNvPr id="41" name="图片 40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610" t="57920" r="58515" b="22889"/>
            <a:stretch/>
          </p:blipFill>
          <p:spPr>
            <a:xfrm>
              <a:off x="3980776" y="2348880"/>
              <a:ext cx="1321970" cy="1315617"/>
            </a:xfrm>
            <a:prstGeom prst="rect">
              <a:avLst/>
            </a:prstGeom>
          </p:spPr>
        </p:pic>
        <p:pic>
          <p:nvPicPr>
            <p:cNvPr id="42" name="图片 4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900" t="57920" r="72971" b="22889"/>
            <a:stretch/>
          </p:blipFill>
          <p:spPr>
            <a:xfrm>
              <a:off x="2630477" y="2380640"/>
              <a:ext cx="1293451" cy="1315617"/>
            </a:xfrm>
            <a:prstGeom prst="rect">
              <a:avLst/>
            </a:prstGeom>
          </p:spPr>
        </p:pic>
        <p:pic>
          <p:nvPicPr>
            <p:cNvPr id="43" name="图片 4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359" t="8147" r="45370" b="73887"/>
            <a:stretch/>
          </p:blipFill>
          <p:spPr>
            <a:xfrm>
              <a:off x="3997821" y="3720838"/>
              <a:ext cx="1304925" cy="1231641"/>
            </a:xfrm>
            <a:prstGeom prst="rect">
              <a:avLst/>
            </a:prstGeom>
          </p:spPr>
        </p:pic>
        <p:pic>
          <p:nvPicPr>
            <p:cNvPr id="44" name="图片 4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430" t="8147" r="17257" b="73887"/>
            <a:stretch/>
          </p:blipFill>
          <p:spPr>
            <a:xfrm>
              <a:off x="5349900" y="3726427"/>
              <a:ext cx="942975" cy="1231641"/>
            </a:xfrm>
            <a:prstGeom prst="rect">
              <a:avLst/>
            </a:prstGeom>
          </p:spPr>
        </p:pic>
        <p:pic>
          <p:nvPicPr>
            <p:cNvPr id="45" name="图片 4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68" t="8147" r="63074" b="73887"/>
            <a:stretch/>
          </p:blipFill>
          <p:spPr>
            <a:xfrm>
              <a:off x="2597658" y="3726428"/>
              <a:ext cx="1340296" cy="1231641"/>
            </a:xfrm>
            <a:prstGeom prst="rect">
              <a:avLst/>
            </a:prstGeom>
          </p:spPr>
        </p:pic>
        <p:pic>
          <p:nvPicPr>
            <p:cNvPr id="46" name="图片 4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680" t="64609" r="62628" b="17560"/>
            <a:stretch/>
          </p:blipFill>
          <p:spPr>
            <a:xfrm>
              <a:off x="2580583" y="5056446"/>
              <a:ext cx="1343345" cy="1222311"/>
            </a:xfrm>
            <a:prstGeom prst="rect">
              <a:avLst/>
            </a:prstGeom>
          </p:spPr>
        </p:pic>
        <p:pic>
          <p:nvPicPr>
            <p:cNvPr id="47" name="图片 4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802" t="64609" r="43924" b="17560"/>
            <a:stretch/>
          </p:blipFill>
          <p:spPr>
            <a:xfrm>
              <a:off x="3998220" y="5057934"/>
              <a:ext cx="1305271" cy="1222311"/>
            </a:xfrm>
            <a:prstGeom prst="rect">
              <a:avLst/>
            </a:prstGeom>
          </p:spPr>
        </p:pic>
        <p:pic>
          <p:nvPicPr>
            <p:cNvPr id="48" name="图片 47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635" t="64609" r="15739" b="17560"/>
            <a:stretch/>
          </p:blipFill>
          <p:spPr>
            <a:xfrm>
              <a:off x="5316485" y="5056445"/>
              <a:ext cx="971550" cy="1222311"/>
            </a:xfrm>
            <a:prstGeom prst="rect">
              <a:avLst/>
            </a:prstGeom>
          </p:spPr>
        </p:pic>
        <p:sp>
          <p:nvSpPr>
            <p:cNvPr id="49" name="TextBox 48"/>
            <p:cNvSpPr txBox="1"/>
            <p:nvPr/>
          </p:nvSpPr>
          <p:spPr>
            <a:xfrm>
              <a:off x="2109820" y="467380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7</a:t>
              </a:r>
              <a:endParaRPr lang="zh-CN" altLang="en-US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627784" y="467380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4</a:t>
              </a:r>
              <a:endParaRPr lang="zh-CN" altLang="en-US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066434" y="467380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6</a:t>
              </a:r>
              <a:endParaRPr lang="zh-CN" altLang="en-US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477972" y="462412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3</a:t>
              </a:r>
              <a:endParaRPr lang="zh-CN" altLang="en-US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003884" y="476672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2</a:t>
              </a:r>
              <a:endParaRPr lang="zh-CN" altLang="en-US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414076" y="476672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1</a:t>
              </a:r>
              <a:endParaRPr lang="zh-CN" altLang="en-US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822766" y="476672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5</a:t>
              </a:r>
              <a:endParaRPr lang="zh-CN" altLang="en-US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273745" y="467070"/>
              <a:ext cx="5174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+</a:t>
              </a:r>
              <a:r>
                <a:rPr lang="en-US" altLang="zh-CN" dirty="0" err="1" smtClean="0"/>
                <a:t>ve</a:t>
              </a:r>
              <a:endParaRPr lang="zh-CN" altLang="en-US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779697" y="462412"/>
              <a:ext cx="47256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-</a:t>
              </a:r>
              <a:r>
                <a:rPr lang="en-US" altLang="zh-CN" dirty="0" err="1" smtClean="0"/>
                <a:t>ve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41064811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组合 58"/>
          <p:cNvGrpSpPr/>
          <p:nvPr/>
        </p:nvGrpSpPr>
        <p:grpSpPr>
          <a:xfrm>
            <a:off x="448085" y="427520"/>
            <a:ext cx="5534480" cy="6217499"/>
            <a:chOff x="448085" y="427520"/>
            <a:chExt cx="5534480" cy="6217499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11" t="14952" r="86635" b="63271"/>
            <a:stretch/>
          </p:blipFill>
          <p:spPr>
            <a:xfrm>
              <a:off x="1590675" y="867543"/>
              <a:ext cx="893093" cy="1492898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53" t="72284" r="86639" b="7708"/>
            <a:stretch/>
          </p:blipFill>
          <p:spPr>
            <a:xfrm>
              <a:off x="1619672" y="2451719"/>
              <a:ext cx="864096" cy="1371600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75" t="14271" r="81023" b="65721"/>
            <a:stretch/>
          </p:blipFill>
          <p:spPr>
            <a:xfrm>
              <a:off x="1619672" y="3888430"/>
              <a:ext cx="806747" cy="1371601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91" t="69502" r="80907" b="12396"/>
            <a:stretch/>
          </p:blipFill>
          <p:spPr>
            <a:xfrm>
              <a:off x="1619672" y="5404047"/>
              <a:ext cx="806747" cy="1240972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510505" y="467380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E: 62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48085" y="1146810"/>
              <a:ext cx="10246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Genomic</a:t>
              </a:r>
              <a:endParaRPr lang="zh-CN" alt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48085" y="2757124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0 DAH</a:t>
              </a:r>
              <a:endParaRPr lang="zh-CN" alt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48085" y="4272056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1 DAH</a:t>
              </a:r>
              <a:endParaRPr lang="zh-CN" altLang="en-US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48085" y="5723964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3 DAH</a:t>
              </a:r>
              <a:endParaRPr lang="zh-CN" altLang="en-US" dirty="0"/>
            </a:p>
          </p:txBody>
        </p:sp>
        <p:pic>
          <p:nvPicPr>
            <p:cNvPr id="38" name="图片 3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440" t="14952" r="38971" b="63271"/>
            <a:stretch/>
          </p:blipFill>
          <p:spPr>
            <a:xfrm>
              <a:off x="5006682" y="881000"/>
              <a:ext cx="876300" cy="1492898"/>
            </a:xfrm>
            <a:prstGeom prst="rect">
              <a:avLst/>
            </a:prstGeom>
          </p:spPr>
        </p:pic>
        <p:pic>
          <p:nvPicPr>
            <p:cNvPr id="39" name="图片 38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701" t="14952" r="57816" b="63271"/>
            <a:stretch/>
          </p:blipFill>
          <p:spPr>
            <a:xfrm>
              <a:off x="3756289" y="876398"/>
              <a:ext cx="1171575" cy="1492898"/>
            </a:xfrm>
            <a:prstGeom prst="rect">
              <a:avLst/>
            </a:prstGeom>
          </p:spPr>
        </p:pic>
        <p:pic>
          <p:nvPicPr>
            <p:cNvPr id="40" name="图片 39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71" t="14952" r="72625" b="63271"/>
            <a:stretch/>
          </p:blipFill>
          <p:spPr>
            <a:xfrm>
              <a:off x="2548917" y="868399"/>
              <a:ext cx="1143000" cy="1492898"/>
            </a:xfrm>
            <a:prstGeom prst="rect">
              <a:avLst/>
            </a:prstGeom>
          </p:spPr>
        </p:pic>
        <p:pic>
          <p:nvPicPr>
            <p:cNvPr id="41" name="图片 40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56" t="72284" r="71968" b="7708"/>
            <a:stretch/>
          </p:blipFill>
          <p:spPr>
            <a:xfrm>
              <a:off x="2542464" y="2451719"/>
              <a:ext cx="1149453" cy="1371600"/>
            </a:xfrm>
            <a:prstGeom prst="rect">
              <a:avLst/>
            </a:prstGeom>
          </p:spPr>
        </p:pic>
        <p:pic>
          <p:nvPicPr>
            <p:cNvPr id="42" name="图片 4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481" t="72284" r="38929" b="7708"/>
            <a:stretch/>
          </p:blipFill>
          <p:spPr>
            <a:xfrm>
              <a:off x="5004048" y="2440656"/>
              <a:ext cx="876300" cy="1371600"/>
            </a:xfrm>
            <a:prstGeom prst="rect">
              <a:avLst/>
            </a:prstGeom>
          </p:spPr>
        </p:pic>
        <p:pic>
          <p:nvPicPr>
            <p:cNvPr id="43" name="图片 4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693" t="72284" r="56889" b="7708"/>
            <a:stretch/>
          </p:blipFill>
          <p:spPr>
            <a:xfrm>
              <a:off x="3754933" y="2440656"/>
              <a:ext cx="1170521" cy="1371600"/>
            </a:xfrm>
            <a:prstGeom prst="rect">
              <a:avLst/>
            </a:prstGeom>
          </p:spPr>
        </p:pic>
        <p:pic>
          <p:nvPicPr>
            <p:cNvPr id="44" name="图片 4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65" t="14271" r="62857" b="65721"/>
            <a:stretch/>
          </p:blipFill>
          <p:spPr>
            <a:xfrm>
              <a:off x="2505815" y="3888429"/>
              <a:ext cx="1186102" cy="1371601"/>
            </a:xfrm>
            <a:prstGeom prst="rect">
              <a:avLst/>
            </a:prstGeom>
          </p:spPr>
        </p:pic>
        <p:pic>
          <p:nvPicPr>
            <p:cNvPr id="45" name="图片 4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746" t="14271" r="45400" b="65721"/>
            <a:stretch/>
          </p:blipFill>
          <p:spPr>
            <a:xfrm>
              <a:off x="3757008" y="3888427"/>
              <a:ext cx="1157926" cy="1371601"/>
            </a:xfrm>
            <a:prstGeom prst="rect">
              <a:avLst/>
            </a:prstGeom>
          </p:spPr>
        </p:pic>
        <p:pic>
          <p:nvPicPr>
            <p:cNvPr id="46" name="图片 4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547" t="14271" r="26765" b="65721"/>
            <a:stretch/>
          </p:blipFill>
          <p:spPr>
            <a:xfrm>
              <a:off x="5004048" y="3881556"/>
              <a:ext cx="885825" cy="1371601"/>
            </a:xfrm>
            <a:prstGeom prst="rect">
              <a:avLst/>
            </a:prstGeom>
          </p:spPr>
        </p:pic>
        <p:pic>
          <p:nvPicPr>
            <p:cNvPr id="47" name="图片 4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14" t="69502" r="63391" b="12396"/>
            <a:stretch/>
          </p:blipFill>
          <p:spPr>
            <a:xfrm>
              <a:off x="2483768" y="5404047"/>
              <a:ext cx="1243171" cy="1240972"/>
            </a:xfrm>
            <a:prstGeom prst="rect">
              <a:avLst/>
            </a:prstGeom>
          </p:spPr>
        </p:pic>
        <p:pic>
          <p:nvPicPr>
            <p:cNvPr id="48" name="图片 47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581" t="69502" r="44415" b="12396"/>
            <a:stretch/>
          </p:blipFill>
          <p:spPr>
            <a:xfrm>
              <a:off x="3757009" y="5404047"/>
              <a:ext cx="1157926" cy="1240972"/>
            </a:xfrm>
            <a:prstGeom prst="rect">
              <a:avLst/>
            </a:prstGeom>
          </p:spPr>
        </p:pic>
        <p:pic>
          <p:nvPicPr>
            <p:cNvPr id="49" name="图片 48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069" t="69502" r="25826" b="12396"/>
            <a:stretch/>
          </p:blipFill>
          <p:spPr>
            <a:xfrm>
              <a:off x="5016227" y="5404047"/>
              <a:ext cx="864121" cy="1240972"/>
            </a:xfrm>
            <a:prstGeom prst="rect">
              <a:avLst/>
            </a:prstGeom>
          </p:spPr>
        </p:pic>
        <p:sp>
          <p:nvSpPr>
            <p:cNvPr id="50" name="TextBox 49"/>
            <p:cNvSpPr txBox="1"/>
            <p:nvPr/>
          </p:nvSpPr>
          <p:spPr>
            <a:xfrm>
              <a:off x="2109820" y="467380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7</a:t>
              </a:r>
              <a:endParaRPr lang="zh-CN" altLang="en-US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548917" y="467380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4</a:t>
              </a:r>
              <a:endParaRPr lang="zh-CN" altLang="en-US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897439" y="467380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6</a:t>
              </a:r>
              <a:endParaRPr lang="zh-CN" altLang="en-US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308977" y="462412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3</a:t>
              </a:r>
              <a:endParaRPr lang="zh-CN" altLang="en-US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3707904" y="476672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2</a:t>
              </a:r>
              <a:endParaRPr lang="zh-CN" altLang="en-US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091350" y="476672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1</a:t>
              </a:r>
              <a:endParaRPr lang="zh-CN" altLang="en-US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526786" y="476672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5</a:t>
              </a:r>
              <a:endParaRPr lang="zh-CN" altLang="en-US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004048" y="432178"/>
              <a:ext cx="5174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+</a:t>
              </a:r>
              <a:r>
                <a:rPr lang="en-US" altLang="zh-CN" dirty="0" err="1" smtClean="0"/>
                <a:t>ve</a:t>
              </a:r>
              <a:endParaRPr lang="zh-CN" altLang="en-US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5510000" y="427520"/>
              <a:ext cx="47256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-</a:t>
              </a:r>
              <a:r>
                <a:rPr lang="en-US" altLang="zh-CN" dirty="0" err="1" smtClean="0"/>
                <a:t>ve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6258702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组合 49"/>
          <p:cNvGrpSpPr/>
          <p:nvPr/>
        </p:nvGrpSpPr>
        <p:grpSpPr>
          <a:xfrm>
            <a:off x="307000" y="611396"/>
            <a:ext cx="6140161" cy="6201108"/>
            <a:chOff x="307000" y="611396"/>
            <a:chExt cx="6140161" cy="6201108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84" t="12502" r="85328" b="68170"/>
            <a:stretch/>
          </p:blipFill>
          <p:spPr>
            <a:xfrm>
              <a:off x="1555963" y="1065107"/>
              <a:ext cx="1013851" cy="1324947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84" t="68338" r="84918" b="11245"/>
            <a:stretch/>
          </p:blipFill>
          <p:spPr>
            <a:xfrm>
              <a:off x="1573095" y="2433259"/>
              <a:ext cx="1051330" cy="1399592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46" t="18083" r="85026" b="60276"/>
            <a:stretch/>
          </p:blipFill>
          <p:spPr>
            <a:xfrm>
              <a:off x="1628776" y="3892632"/>
              <a:ext cx="910523" cy="1483568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05" t="73198" r="85040" b="7067"/>
            <a:stretch/>
          </p:blipFill>
          <p:spPr>
            <a:xfrm>
              <a:off x="1668719" y="5455975"/>
              <a:ext cx="788338" cy="1352938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564985" y="692017"/>
              <a:ext cx="6399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F: 63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07000" y="1411594"/>
              <a:ext cx="10246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Genomic</a:t>
              </a:r>
              <a:endParaRPr lang="zh-CN" alt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33732" y="2837680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0 DAH</a:t>
              </a:r>
              <a:endParaRPr lang="zh-CN" alt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33731" y="4405541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1 DAH</a:t>
              </a:r>
              <a:endParaRPr lang="zh-CN" altLang="en-US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67544" y="5867980"/>
              <a:ext cx="771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3 DAH</a:t>
              </a:r>
              <a:endParaRPr lang="zh-CN" altLang="en-US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093343" y="651256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7</a:t>
              </a:r>
              <a:endParaRPr lang="zh-CN" altLang="en-US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737154" y="651256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4</a:t>
              </a:r>
              <a:endParaRPr lang="zh-CN" altLang="en-US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130431" y="651256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6</a:t>
              </a:r>
              <a:endParaRPr lang="zh-CN" altLang="en-US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590938" y="646288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3</a:t>
              </a:r>
              <a:endParaRPr lang="zh-CN" altLang="en-US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096052" y="646288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2</a:t>
              </a:r>
              <a:endParaRPr lang="zh-CN" altLang="en-US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479498" y="646288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1</a:t>
              </a:r>
              <a:endParaRPr lang="zh-CN" altLang="en-US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914934" y="646288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H5</a:t>
              </a:r>
              <a:endParaRPr lang="zh-CN" altLang="en-US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468644" y="616054"/>
              <a:ext cx="5174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+</a:t>
              </a:r>
              <a:r>
                <a:rPr lang="en-US" altLang="zh-CN" dirty="0" err="1" smtClean="0"/>
                <a:t>ve</a:t>
              </a:r>
              <a:endParaRPr lang="zh-CN" altLang="en-US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974596" y="611396"/>
              <a:ext cx="47256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-</a:t>
              </a:r>
              <a:r>
                <a:rPr lang="en-US" altLang="zh-CN" dirty="0" err="1" smtClean="0"/>
                <a:t>ve</a:t>
              </a:r>
              <a:endParaRPr lang="zh-CN" altLang="en-US" dirty="0"/>
            </a:p>
          </p:txBody>
        </p:sp>
        <p:pic>
          <p:nvPicPr>
            <p:cNvPr id="37" name="图片 3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712" t="12502" r="26288" b="68170"/>
            <a:stretch/>
          </p:blipFill>
          <p:spPr>
            <a:xfrm>
              <a:off x="5425782" y="1065107"/>
              <a:ext cx="914400" cy="1324947"/>
            </a:xfrm>
            <a:prstGeom prst="rect">
              <a:avLst/>
            </a:prstGeom>
          </p:spPr>
        </p:pic>
        <p:pic>
          <p:nvPicPr>
            <p:cNvPr id="38" name="图片 3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35" t="12502" r="49143" b="68170"/>
            <a:stretch/>
          </p:blipFill>
          <p:spPr>
            <a:xfrm>
              <a:off x="4082226" y="1061349"/>
              <a:ext cx="1318751" cy="1324947"/>
            </a:xfrm>
            <a:prstGeom prst="rect">
              <a:avLst/>
            </a:prstGeom>
          </p:spPr>
        </p:pic>
        <p:pic>
          <p:nvPicPr>
            <p:cNvPr id="39" name="图片 38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967" t="12502" r="67307" b="68170"/>
            <a:stretch/>
          </p:blipFill>
          <p:spPr>
            <a:xfrm>
              <a:off x="2680105" y="1065107"/>
              <a:ext cx="1346609" cy="1324947"/>
            </a:xfrm>
            <a:prstGeom prst="rect">
              <a:avLst/>
            </a:prstGeom>
          </p:spPr>
        </p:pic>
        <p:pic>
          <p:nvPicPr>
            <p:cNvPr id="40" name="图片 39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955" t="68338" r="25837" b="11245"/>
            <a:stretch/>
          </p:blipFill>
          <p:spPr>
            <a:xfrm>
              <a:off x="5416257" y="2429439"/>
              <a:ext cx="933450" cy="1399592"/>
            </a:xfrm>
            <a:prstGeom prst="rect">
              <a:avLst/>
            </a:prstGeom>
          </p:spPr>
        </p:pic>
        <p:pic>
          <p:nvPicPr>
            <p:cNvPr id="42" name="图片 4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04" t="68338" r="67769" b="11245"/>
            <a:stretch/>
          </p:blipFill>
          <p:spPr>
            <a:xfrm>
              <a:off x="2699792" y="2441476"/>
              <a:ext cx="1346609" cy="1399592"/>
            </a:xfrm>
            <a:prstGeom prst="rect">
              <a:avLst/>
            </a:prstGeom>
          </p:spPr>
        </p:pic>
        <p:pic>
          <p:nvPicPr>
            <p:cNvPr id="43" name="图片 4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03" t="68338" r="49326" b="11245"/>
            <a:stretch/>
          </p:blipFill>
          <p:spPr>
            <a:xfrm>
              <a:off x="4096052" y="2433259"/>
              <a:ext cx="1304925" cy="1399592"/>
            </a:xfrm>
            <a:prstGeom prst="rect">
              <a:avLst/>
            </a:prstGeom>
          </p:spPr>
        </p:pic>
        <p:pic>
          <p:nvPicPr>
            <p:cNvPr id="44" name="图片 4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721" t="18083" r="56117" b="60276"/>
            <a:stretch/>
          </p:blipFill>
          <p:spPr>
            <a:xfrm>
              <a:off x="4026714" y="3924590"/>
              <a:ext cx="1334176" cy="1483568"/>
            </a:xfrm>
            <a:prstGeom prst="rect">
              <a:avLst/>
            </a:prstGeom>
          </p:spPr>
        </p:pic>
        <p:pic>
          <p:nvPicPr>
            <p:cNvPr id="45" name="图片 4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150" t="18083" r="70777" b="60276"/>
            <a:stretch/>
          </p:blipFill>
          <p:spPr>
            <a:xfrm>
              <a:off x="2664457" y="3905952"/>
              <a:ext cx="1259471" cy="1483568"/>
            </a:xfrm>
            <a:prstGeom prst="rect">
              <a:avLst/>
            </a:prstGeom>
          </p:spPr>
        </p:pic>
        <p:pic>
          <p:nvPicPr>
            <p:cNvPr id="46" name="图片 4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389" t="18083" r="37762" b="60276"/>
            <a:stretch/>
          </p:blipFill>
          <p:spPr>
            <a:xfrm>
              <a:off x="5409445" y="3869806"/>
              <a:ext cx="940262" cy="1483568"/>
            </a:xfrm>
            <a:prstGeom prst="rect">
              <a:avLst/>
            </a:prstGeom>
          </p:spPr>
        </p:pic>
        <p:pic>
          <p:nvPicPr>
            <p:cNvPr id="47" name="图片 4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68" t="73198" r="69961" b="7067"/>
            <a:stretch/>
          </p:blipFill>
          <p:spPr>
            <a:xfrm>
              <a:off x="2636951" y="5455975"/>
              <a:ext cx="1301220" cy="1352938"/>
            </a:xfrm>
            <a:prstGeom prst="rect">
              <a:avLst/>
            </a:prstGeom>
          </p:spPr>
        </p:pic>
        <p:pic>
          <p:nvPicPr>
            <p:cNvPr id="48" name="图片 47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013" t="73198" r="37045" b="7067"/>
            <a:stretch/>
          </p:blipFill>
          <p:spPr>
            <a:xfrm>
              <a:off x="5407832" y="5455975"/>
              <a:ext cx="932350" cy="1352938"/>
            </a:xfrm>
            <a:prstGeom prst="rect">
              <a:avLst/>
            </a:prstGeom>
          </p:spPr>
        </p:pic>
        <p:pic>
          <p:nvPicPr>
            <p:cNvPr id="49" name="图片 48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818" t="73198" r="55935" b="7067"/>
            <a:stretch/>
          </p:blipFill>
          <p:spPr>
            <a:xfrm>
              <a:off x="4026714" y="5459566"/>
              <a:ext cx="1334176" cy="135293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569507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43608" y="836712"/>
            <a:ext cx="7128792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. S1 </a:t>
            </a:r>
            <a:r>
              <a:rPr lang="en-US" altLang="zh-CN" b="1" dirty="0" smtClean="0"/>
              <a:t>Expression of MeF6’H genes were verified by RT-PCR at various annealing temperatures</a:t>
            </a:r>
            <a:r>
              <a:rPr lang="en-US" altLang="zh-CN" dirty="0" smtClean="0"/>
              <a:t>.  Genes whose bands appear and disappear at the same temperature in PCR with genomic or </a:t>
            </a:r>
            <a:r>
              <a:rPr lang="en-US" altLang="zh-CN" dirty="0" err="1" smtClean="0"/>
              <a:t>cDNA</a:t>
            </a:r>
            <a:r>
              <a:rPr lang="en-US" altLang="zh-CN" dirty="0" smtClean="0"/>
              <a:t> as templates are considered as actively expressed. H1: MeF6’H1; H2: MeF6’H2; H3: MeF6’H3; H4: MeF6’H4; H5: MeF6’H5; H6: MeF6’H6; H7: MeF6’H7; +</a:t>
            </a:r>
            <a:r>
              <a:rPr lang="en-US" altLang="zh-CN" dirty="0" err="1" smtClean="0"/>
              <a:t>ve</a:t>
            </a:r>
            <a:r>
              <a:rPr lang="en-US" altLang="zh-CN" dirty="0" smtClean="0"/>
              <a:t>: </a:t>
            </a:r>
            <a:r>
              <a:rPr lang="en-US" altLang="zh-CN" dirty="0"/>
              <a:t>positive control (PP2A, for.: TGCAAGGCTCACACTTTCATC, rev.: </a:t>
            </a:r>
            <a:r>
              <a:rPr lang="en-US" altLang="zh-CN" dirty="0" smtClean="0"/>
              <a:t>CTGAGCGTAAAGCAGGGAAG); -</a:t>
            </a:r>
            <a:r>
              <a:rPr lang="en-US" altLang="zh-CN" dirty="0" err="1" smtClean="0"/>
              <a:t>ve</a:t>
            </a:r>
            <a:r>
              <a:rPr lang="en-US" altLang="zh-CN" dirty="0" smtClean="0"/>
              <a:t>: negative control. Genomic: cassava genomic DNA as template; 0 DAH: </a:t>
            </a:r>
            <a:r>
              <a:rPr lang="en-US" altLang="zh-CN" dirty="0" err="1" smtClean="0"/>
              <a:t>cDNA</a:t>
            </a:r>
            <a:r>
              <a:rPr lang="en-US" altLang="zh-CN" dirty="0" smtClean="0"/>
              <a:t> from fresh cassava root as template; 1 DAH: </a:t>
            </a:r>
            <a:r>
              <a:rPr lang="en-US" altLang="zh-CN" dirty="0" err="1" smtClean="0"/>
              <a:t>cDNA</a:t>
            </a:r>
            <a:r>
              <a:rPr lang="en-US" altLang="zh-CN" dirty="0" smtClean="0"/>
              <a:t> from cassava roots (1 day after harvest) as template; 3 DAH: </a:t>
            </a:r>
            <a:r>
              <a:rPr lang="en-US" altLang="zh-CN" dirty="0" err="1" smtClean="0"/>
              <a:t>cDNA</a:t>
            </a:r>
            <a:r>
              <a:rPr lang="en-US" altLang="zh-CN" dirty="0" smtClean="0"/>
              <a:t> from cassava roots (3 days after harvest) as template. (A): annealing temperature 58</a:t>
            </a:r>
            <a:r>
              <a:rPr lang="zh-CN" altLang="en-US" dirty="0" smtClean="0"/>
              <a:t>℃</a:t>
            </a:r>
            <a:r>
              <a:rPr lang="en-US" altLang="zh-CN" dirty="0" smtClean="0"/>
              <a:t>; (B): </a:t>
            </a:r>
            <a:r>
              <a:rPr lang="en-US" altLang="zh-CN" dirty="0"/>
              <a:t>annealing temperature </a:t>
            </a:r>
            <a:r>
              <a:rPr lang="en-US" altLang="zh-CN" dirty="0" smtClean="0"/>
              <a:t>59</a:t>
            </a:r>
            <a:r>
              <a:rPr lang="zh-CN" altLang="en-US" dirty="0" smtClean="0"/>
              <a:t>℃</a:t>
            </a:r>
            <a:r>
              <a:rPr lang="en-US" altLang="zh-CN" dirty="0"/>
              <a:t>; </a:t>
            </a:r>
            <a:r>
              <a:rPr lang="en-US" altLang="zh-CN" dirty="0" smtClean="0"/>
              <a:t>(C): </a:t>
            </a:r>
            <a:r>
              <a:rPr lang="en-US" altLang="zh-CN" dirty="0"/>
              <a:t>annealing temperature </a:t>
            </a:r>
            <a:r>
              <a:rPr lang="en-US" altLang="zh-CN" dirty="0" smtClean="0"/>
              <a:t>60</a:t>
            </a:r>
            <a:r>
              <a:rPr lang="zh-CN" altLang="en-US" dirty="0" smtClean="0"/>
              <a:t>℃</a:t>
            </a:r>
            <a:r>
              <a:rPr lang="en-US" altLang="zh-CN" dirty="0"/>
              <a:t>; </a:t>
            </a:r>
            <a:r>
              <a:rPr lang="en-US" altLang="zh-CN" dirty="0" smtClean="0"/>
              <a:t>(D): </a:t>
            </a:r>
            <a:r>
              <a:rPr lang="en-US" altLang="zh-CN" dirty="0"/>
              <a:t>annealing temperature </a:t>
            </a:r>
            <a:r>
              <a:rPr lang="en-US" altLang="zh-CN" dirty="0" smtClean="0"/>
              <a:t>61</a:t>
            </a:r>
            <a:r>
              <a:rPr lang="zh-CN" altLang="en-US" dirty="0" smtClean="0"/>
              <a:t>℃</a:t>
            </a:r>
            <a:r>
              <a:rPr lang="en-US" altLang="zh-CN" dirty="0"/>
              <a:t>; </a:t>
            </a:r>
            <a:r>
              <a:rPr lang="en-US" altLang="zh-CN" dirty="0" smtClean="0"/>
              <a:t>(E): </a:t>
            </a:r>
            <a:r>
              <a:rPr lang="en-US" altLang="zh-CN" dirty="0"/>
              <a:t>annealing temperature </a:t>
            </a:r>
            <a:r>
              <a:rPr lang="en-US" altLang="zh-CN" dirty="0" smtClean="0"/>
              <a:t>62</a:t>
            </a:r>
            <a:r>
              <a:rPr lang="zh-CN" altLang="en-US" dirty="0" smtClean="0"/>
              <a:t>℃</a:t>
            </a:r>
            <a:r>
              <a:rPr lang="en-US" altLang="zh-CN" dirty="0"/>
              <a:t>; </a:t>
            </a:r>
            <a:r>
              <a:rPr lang="en-US" altLang="zh-CN" dirty="0" smtClean="0"/>
              <a:t>(F): </a:t>
            </a:r>
            <a:r>
              <a:rPr lang="en-US" altLang="zh-CN" dirty="0"/>
              <a:t>annealing temperature </a:t>
            </a:r>
            <a:r>
              <a:rPr lang="en-US" altLang="zh-CN" dirty="0" smtClean="0"/>
              <a:t>63</a:t>
            </a:r>
            <a:r>
              <a:rPr lang="zh-CN" altLang="en-US" dirty="0" smtClean="0"/>
              <a:t>℃</a:t>
            </a:r>
            <a:r>
              <a:rPr lang="en-US" altLang="zh-CN" dirty="0" smtClean="0"/>
              <a:t>.</a:t>
            </a:r>
            <a:endParaRPr lang="zh-CN" altLang="en-US" dirty="0"/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31264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317</Words>
  <Application>Microsoft Office PowerPoint</Application>
  <PresentationFormat>全屏显示(4:3)</PresentationFormat>
  <Paragraphs>87</Paragraphs>
  <Slides>7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 Liu</dc:creator>
  <cp:lastModifiedBy>HP</cp:lastModifiedBy>
  <cp:revision>4</cp:revision>
  <dcterms:created xsi:type="dcterms:W3CDTF">2016-12-15T14:12:52Z</dcterms:created>
  <dcterms:modified xsi:type="dcterms:W3CDTF">2016-12-15T14:57:58Z</dcterms:modified>
</cp:coreProperties>
</file>